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>
      <p:cViewPr varScale="1">
        <p:scale>
          <a:sx n="87" d="100"/>
          <a:sy n="87" d="100"/>
        </p:scale>
        <p:origin x="80" y="8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CBD339-C323-775E-F307-0E5A7D2365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4538DF3-60B5-FE80-B0AA-5986FA5904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D19F4C-3058-C0CA-894C-1E758FD37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1AB792-7F41-BD36-FA62-48664924E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39B7CE-13F0-1FC2-AC9F-E812ED6EEB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895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071D25-EA2D-EF5D-1900-8C21A2BCE7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859D4F5-4933-2F83-203A-37F9C61923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9A97A2-0840-A869-469F-F3A0ACC1D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302726-00A0-ACEF-6A63-5A8F8F4DF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03725E-B015-AC10-D5EB-71EB1636D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2551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9D1B2FD-1969-9C1D-785A-7FCF24537C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C3B5142-92E9-E485-FB06-057137565E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BFF024-07FC-6171-DF82-4D355DDCA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0526D0-F7F9-FAFC-077E-A81E057740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ADC7B6D-ECD2-CC61-9D2B-B86F6A647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771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05EA8F-8CBE-0F26-B153-9C88D43751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1ACB70-1635-7E5B-DDEA-A20AD22921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A9CA21-9C5E-C649-B844-B7253D1CB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4C636D-77B7-0582-E44D-9BB7EDDC7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AA9D4B-EAC4-2D80-E28B-E2E8B0CDD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6753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6333DB-0460-92EB-B394-13C5A5FAE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060D3AE-D0E5-B236-3C11-B0F72A61D1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BC06BD-31A1-EAF8-C175-5E2FE003B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90661E-713C-17F4-91FC-6F5A95BB9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69EE93-BC46-845A-C70C-2C77EB32E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3525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2847FE-47EE-591C-D9A8-F88CC8EFC6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08BAC38-3980-0EC5-7AA8-8A800BDFD1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E9DF9C8-548D-F45F-57D8-64034368C3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DDCA114-0279-138C-818E-93BFE81BB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BCE686-5FE6-F356-76AD-50A655651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4A5A4F2-F793-11AB-7CC9-5F08FA080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304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4B4B01-BDCF-3156-3A74-797157280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05B33FA-618C-3DDE-1929-C6AFB5D6FE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1BCF52F-10BA-9643-A535-B4BC17B292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CC127BE-0066-0528-E9FD-306B1AF035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DEB9545-16B6-61F7-E7FB-A0D89C33C9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E129382-640E-766D-A434-E560B5D51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F791EFA-6F50-0EC5-1888-E87D8FB9F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7B43867-0A59-FD06-A9B3-095579EA8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841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979571F-0C57-1B5B-8480-BC562C3691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78E19BE-73C6-AA08-7EA5-7BD8BFF10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BBFB900-39EA-1737-1D7C-26CD38C67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753402F-C704-AD28-86BA-3B6134B8C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3392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F30EE33-E284-BA3D-BEF0-43E592786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EBE265E-168B-EE08-89C1-F16948C81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E81EF64-0D36-1C3B-B32E-C54E17C21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5595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AC53F4-BB43-33B0-00D9-8E59CC500B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A73C67-CBCB-170F-D076-26AD8056B7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D99D780-B23D-C1EB-D96C-334FCA4A49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C8B011-921A-A6FC-3400-2A55C2649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15BC64-52D2-141E-CAD8-B07204A60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9D5BD3D-BAF4-5B5F-41C7-61343A9F4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699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E9B1E8-9E51-8278-4FE7-77F14F5D6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7271E63-F788-7FC6-C315-605E3E8DB1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9D484CE-E51D-48FB-0E54-FD02804FE1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8B8FCD-E3B1-439F-94C0-0DC408117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5DB743D-CEC3-6ED1-4A38-960C717CF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ACB196-5EB6-D6C7-D2FE-F429D369B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412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66E6AFE-2610-CB7A-DE2F-EB1112114E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ECAC945-8E8C-0655-78B5-2F69D3B76C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7708A2-F45A-B889-7990-D9FDC84F73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3072941-99CB-3696-68F7-CA7E45670B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7DE35FF-0801-455C-D4DB-13079048F5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090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1624972-9DB5-1664-132A-E2658D815896}"/>
              </a:ext>
            </a:extLst>
          </p:cNvPr>
          <p:cNvSpPr txBox="1"/>
          <p:nvPr/>
        </p:nvSpPr>
        <p:spPr>
          <a:xfrm>
            <a:off x="2330559" y="5585402"/>
            <a:ext cx="753088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0. </a:t>
            </a:r>
            <a:r>
              <a:rPr lang="en-US" altLang="ja-JP" sz="1400" b="1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mparison of IL-8 measurements between </a:t>
            </a:r>
            <a:r>
              <a:rPr lang="en-US" altLang="ja-JP" sz="1400" b="1" dirty="0" err="1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omaScan</a:t>
            </a:r>
            <a:r>
              <a:rPr lang="en-US" altLang="ja-JP" sz="1400" b="1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ELISA under delayed processing conditions</a:t>
            </a:r>
            <a:endParaRPr lang="ja-JP" altLang="ja-JP" sz="1400" b="1" dirty="0">
              <a:effectLst/>
              <a:latin typeface="Times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0CAA6CF2-2FF5-31B9-5C34-6924B74F4B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4094" y="165588"/>
            <a:ext cx="8498561" cy="54198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7732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E4AE8A7F-1137-45AA-94AB-9A6945429C1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e658bc-5f5e-48b2-a593-8f2a4dff4e8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462235E-1161-4A26-82DC-978D445758A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00B3D2F-7A00-4CB2-AECD-EA87237B8557}">
  <ds:schemaRefs>
    <ds:schemaRef ds:uri="http://schemas.microsoft.com/office/2006/metadata/properties"/>
    <ds:schemaRef ds:uri="http://schemas.microsoft.com/office/infopath/2007/PartnerControls"/>
    <ds:schemaRef ds:uri="09e658bc-5f5e-48b2-a593-8f2a4dff4e86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5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Times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6</cp:revision>
  <dcterms:created xsi:type="dcterms:W3CDTF">2026-03-31T01:02:07Z</dcterms:created>
  <dcterms:modified xsi:type="dcterms:W3CDTF">2026-03-31T08:00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</Properties>
</file>